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687" autoAdjust="0"/>
  </p:normalViewPr>
  <p:slideViewPr>
    <p:cSldViewPr snapToGrid="0" snapToObjects="1">
      <p:cViewPr varScale="1">
        <p:scale>
          <a:sx n="155" d="100"/>
          <a:sy n="155" d="100"/>
        </p:scale>
        <p:origin x="-13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019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619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19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639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1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960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814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50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55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17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566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AF7E4-C559-D844-A2E9-42616C95ABC6}" type="datetimeFigureOut">
              <a:rPr lang="en-US" smtClean="0"/>
              <a:t>02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C0D94-74D5-764C-A52F-7578F4F8C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792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9046817"/>
              </p:ext>
            </p:extLst>
          </p:nvPr>
        </p:nvGraphicFramePr>
        <p:xfrm>
          <a:off x="530914" y="803754"/>
          <a:ext cx="8311634" cy="481826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75221"/>
                <a:gridCol w="771713"/>
                <a:gridCol w="884255"/>
                <a:gridCol w="819945"/>
                <a:gridCol w="916410"/>
                <a:gridCol w="819946"/>
                <a:gridCol w="836022"/>
                <a:gridCol w="819946"/>
                <a:gridCol w="868176"/>
              </a:tblGrid>
              <a:tr h="828811"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                         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Osteopontin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</a:p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                           (</a:t>
                      </a:r>
                      <a:r>
                        <a:rPr lang="it-IT" sz="1200" b="1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μg</a:t>
                      </a:r>
                      <a:r>
                        <a:rPr lang="it-IT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/L</a:t>
                      </a:r>
                      <a:r>
                        <a:rPr lang="it-IT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Total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Osteocalcin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ng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Osteoprotegerin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g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TH</a:t>
                      </a:r>
                    </a:p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g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592008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i="1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r</a:t>
                      </a:r>
                      <a:endParaRPr lang="en-US" sz="1200" i="1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 value</a:t>
                      </a:r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i="1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r</a:t>
                      </a:r>
                      <a:endParaRPr lang="en-US" sz="1200" i="1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 value</a:t>
                      </a:r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i="1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r</a:t>
                      </a:r>
                      <a:endParaRPr lang="en-US" sz="1200" i="1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 value</a:t>
                      </a:r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i="1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r</a:t>
                      </a:r>
                      <a:endParaRPr lang="en-US" sz="1200" i="1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i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 value</a:t>
                      </a:r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3741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 smtClean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i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92008">
                <a:tc>
                  <a:txBody>
                    <a:bodyPr/>
                    <a:lstStyle/>
                    <a:p>
                      <a:pPr algn="l" rtl="0">
                        <a:defRPr sz="1000" b="1" i="0" u="none" strike="noStrike" kern="1200" baseline="0">
                          <a:solidFill>
                            <a:sysClr val="windowText" lastClr="000000"/>
                          </a:solidFill>
                          <a:latin typeface="Times New Roman"/>
                          <a:ea typeface="+mn-ea"/>
                          <a:cs typeface="Times New Roman"/>
                        </a:defRPr>
                      </a:pP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Fasting ISR </a:t>
                      </a:r>
                    </a:p>
                    <a:p>
                      <a:pPr algn="l" rtl="0">
                        <a:defRPr sz="1000" b="1" i="0" u="none" strike="noStrike" kern="1200" baseline="0">
                          <a:solidFill>
                            <a:sysClr val="windowText" lastClr="000000"/>
                          </a:solidFill>
                          <a:latin typeface="Times New Roman"/>
                          <a:ea typeface="+mn-ea"/>
                          <a:cs typeface="Times New Roman"/>
                        </a:defRPr>
                      </a:pP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b="1" i="0" baseline="0" dirty="0" err="1" smtClean="0">
                          <a:effectLst/>
                          <a:latin typeface="Times New Roman"/>
                          <a:cs typeface="Times New Roman"/>
                        </a:rPr>
                        <a:t>pmol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/m</a:t>
                      </a:r>
                      <a:r>
                        <a:rPr lang="en-US" sz="1200" b="1" i="0" baseline="30000" dirty="0" smtClean="0"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/min)</a:t>
                      </a:r>
                      <a:endParaRPr lang="en-US" sz="1200" b="1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9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3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93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95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6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5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92008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Total ISR 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b="1" dirty="0" err="1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nmol</a:t>
                      </a: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m</a:t>
                      </a:r>
                      <a:r>
                        <a:rPr lang="en-US" sz="1200" b="1" baseline="3000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n-US" sz="1200" b="1" baseline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200" b="1" baseline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4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66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5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59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7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47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6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5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92008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β-GS 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b="1" i="0" baseline="0" dirty="0" err="1" smtClean="0">
                          <a:effectLst/>
                          <a:latin typeface="Times New Roman"/>
                          <a:cs typeface="Times New Roman"/>
                        </a:rPr>
                        <a:t>pmol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/m</a:t>
                      </a:r>
                      <a:r>
                        <a:rPr lang="en-US" sz="1200" b="1" i="0" baseline="30000" dirty="0" smtClean="0"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/min/</a:t>
                      </a:r>
                      <a:r>
                        <a:rPr lang="en-US" sz="1200" b="1" i="0" baseline="0" dirty="0" err="1" smtClean="0">
                          <a:effectLst/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1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2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11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2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1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26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87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92008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otentiation Factor (ratio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98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9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29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8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37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1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89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92008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Rate sensitivity 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b="1" i="0" baseline="0" dirty="0" err="1" smtClean="0">
                          <a:effectLst/>
                          <a:latin typeface="Times New Roman"/>
                          <a:cs typeface="Times New Roman"/>
                        </a:rPr>
                        <a:t>pmol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/m</a:t>
                      </a:r>
                      <a:r>
                        <a:rPr lang="en-US" sz="1200" b="1" i="0" baseline="30000" dirty="0" smtClean="0"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/</a:t>
                      </a:r>
                      <a:r>
                        <a:rPr lang="en-US" sz="1200" b="1" i="0" baseline="0" dirty="0" err="1" smtClean="0">
                          <a:effectLst/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lang="en-US" sz="1200" b="1" i="0" baseline="0" dirty="0" smtClean="0"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14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13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80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0.01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94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02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smtClean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87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0914" y="362360"/>
            <a:ext cx="1608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kern="1200">
                <a:solidFill>
                  <a:srgbClr val="000000"/>
                </a:solidFill>
                <a:effectLst/>
                <a:latin typeface="Times New Roman"/>
                <a:ea typeface="ＭＳ 明朝"/>
                <a:cs typeface="Times New Roman"/>
              </a:rPr>
              <a:t>Supplementary Table </a:t>
            </a:r>
            <a:r>
              <a:rPr lang="en-US" sz="1200" kern="1200" smtClean="0">
                <a:solidFill>
                  <a:srgbClr val="000000"/>
                </a:solidFill>
                <a:effectLst/>
                <a:latin typeface="Times New Roman"/>
                <a:ea typeface="ＭＳ 明朝"/>
                <a:cs typeface="Times New Roman"/>
              </a:rPr>
              <a:t>4</a:t>
            </a:r>
            <a:endParaRPr lang="it-IT" sz="1000" dirty="0">
              <a:effectLst/>
              <a:latin typeface="Times"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329296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</TotalTime>
  <Words>136</Words>
  <Application>Microsoft Macintosh PowerPoint</Application>
  <PresentationFormat>On-screen Show (4:3)</PresentationFormat>
  <Paragraphs>6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kk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no Strada</dc:creator>
  <cp:lastModifiedBy>Giuseppe Daniele</cp:lastModifiedBy>
  <cp:revision>30</cp:revision>
  <dcterms:created xsi:type="dcterms:W3CDTF">2014-11-29T01:30:02Z</dcterms:created>
  <dcterms:modified xsi:type="dcterms:W3CDTF">2017-03-02T15:10:39Z</dcterms:modified>
</cp:coreProperties>
</file>